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3"/>
  </p:notesMasterIdLst>
  <p:sldIdLst>
    <p:sldId id="274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0" d="100"/>
          <a:sy n="120" d="100"/>
        </p:scale>
        <p:origin x="-810" y="72"/>
      </p:cViewPr>
      <p:guideLst>
        <p:guide orient="horz" pos="3121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Shivaprasad\Desktop\Soham\Abundance%20graphs-1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C:\Users\Shivaprasad\Desktop\Soham\Abundance%20graphs-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5663971424461291E-2"/>
          <c:y val="2.576737724531639E-2"/>
          <c:w val="0.89151848263020894"/>
          <c:h val="0.83539884725874236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C:\Users\Soham\Desktop\5th yr project\Abundance per million\[Segregation_flower.xlsx]Sheet3'!$C$8</c:f>
              <c:strCache>
                <c:ptCount val="1"/>
                <c:pt idx="0">
                  <c:v>UCGCUUGGUGCAGAUCGGGAC</c:v>
                </c:pt>
              </c:strCache>
            </c:strRef>
          </c:tx>
          <c:invertIfNegative val="0"/>
          <c:cat>
            <c:strRef>
              <c:f>'C:\Users\Soham\Desktop\5th yr project\Abundance per million\[Segregation_flower.xlsx]Sheet3'!$B$9:$B$45</c:f>
              <c:strCache>
                <c:ptCount val="37"/>
                <c:pt idx="0">
                  <c:v>ppa</c:v>
                </c:pt>
                <c:pt idx="1">
                  <c:v>sma</c:v>
                </c:pt>
                <c:pt idx="2">
                  <c:v>mqu</c:v>
                </c:pt>
                <c:pt idx="3">
                  <c:v>cru</c:v>
                </c:pt>
                <c:pt idx="4">
                  <c:v>gbi (f)</c:v>
                </c:pt>
                <c:pt idx="5">
                  <c:v>gbi (m)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r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gma</c:v>
                </c:pt>
                <c:pt idx="28">
                  <c:v>pvu</c:v>
                </c:pt>
                <c:pt idx="29">
                  <c:v>sla</c:v>
                </c:pt>
                <c:pt idx="30">
                  <c:v>lsa</c:v>
                </c:pt>
                <c:pt idx="31">
                  <c:v>mgu</c:v>
                </c:pt>
                <c:pt idx="32">
                  <c:v>nta</c:v>
                </c:pt>
                <c:pt idx="33">
                  <c:v>phy</c:v>
                </c:pt>
                <c:pt idx="34">
                  <c:v>can</c:v>
                </c:pt>
                <c:pt idx="35">
                  <c:v>sly</c:v>
                </c:pt>
                <c:pt idx="36">
                  <c:v>stu</c:v>
                </c:pt>
              </c:strCache>
            </c:strRef>
          </c:cat>
          <c:val>
            <c:numRef>
              <c:f>'C:\Users\Soham\Desktop\5th yr project\Abundance per million\[Segregation_flower.xlsx]Sheet3'!$C$9:$C$45</c:f>
              <c:numCache>
                <c:formatCode>General</c:formatCode>
                <c:ptCount val="37"/>
                <c:pt idx="0">
                  <c:v>0</c:v>
                </c:pt>
                <c:pt idx="1">
                  <c:v>0</c:v>
                </c:pt>
                <c:pt idx="2">
                  <c:v>1052.7901316780428</c:v>
                </c:pt>
                <c:pt idx="3">
                  <c:v>2480.3550322485862</c:v>
                </c:pt>
                <c:pt idx="4">
                  <c:v>5625.9520532129509</c:v>
                </c:pt>
                <c:pt idx="5">
                  <c:v>4465.1954859758962</c:v>
                </c:pt>
                <c:pt idx="6">
                  <c:v>2123.2379096525665</c:v>
                </c:pt>
                <c:pt idx="7">
                  <c:v>378.54188444401228</c:v>
                </c:pt>
                <c:pt idx="8">
                  <c:v>3265.2164127932051</c:v>
                </c:pt>
                <c:pt idx="9">
                  <c:v>193.64327862004143</c:v>
                </c:pt>
                <c:pt idx="10">
                  <c:v>4105.8190839808058</c:v>
                </c:pt>
                <c:pt idx="11">
                  <c:v>1992.7925776926611</c:v>
                </c:pt>
                <c:pt idx="12">
                  <c:v>13147.155480552028</c:v>
                </c:pt>
                <c:pt idx="13">
                  <c:v>73265.785467795373</c:v>
                </c:pt>
                <c:pt idx="14">
                  <c:v>12404.850621273261</c:v>
                </c:pt>
                <c:pt idx="15">
                  <c:v>18913.953222537268</c:v>
                </c:pt>
                <c:pt idx="16">
                  <c:v>14523.392516779932</c:v>
                </c:pt>
                <c:pt idx="17">
                  <c:v>18342.216581179782</c:v>
                </c:pt>
                <c:pt idx="18">
                  <c:v>2780.6629808520843</c:v>
                </c:pt>
                <c:pt idx="19">
                  <c:v>49523.246677052564</c:v>
                </c:pt>
                <c:pt idx="20">
                  <c:v>3710.6481402279423</c:v>
                </c:pt>
                <c:pt idx="21">
                  <c:v>3.5361329133350399</c:v>
                </c:pt>
                <c:pt idx="22">
                  <c:v>572.30698970859066</c:v>
                </c:pt>
                <c:pt idx="23">
                  <c:v>692.15511764140501</c:v>
                </c:pt>
                <c:pt idx="24">
                  <c:v>10.691356572778737</c:v>
                </c:pt>
                <c:pt idx="25">
                  <c:v>4104.9509173874249</c:v>
                </c:pt>
                <c:pt idx="26">
                  <c:v>23.004258576231582</c:v>
                </c:pt>
                <c:pt idx="27">
                  <c:v>19.590173568937821</c:v>
                </c:pt>
                <c:pt idx="29">
                  <c:v>13.473948516835302</c:v>
                </c:pt>
                <c:pt idx="30">
                  <c:v>3.7289083620770018</c:v>
                </c:pt>
                <c:pt idx="31">
                  <c:v>11.667131661044463</c:v>
                </c:pt>
                <c:pt idx="32">
                  <c:v>124.41145872435355</c:v>
                </c:pt>
                <c:pt idx="33">
                  <c:v>8.7547011235602294</c:v>
                </c:pt>
                <c:pt idx="34">
                  <c:v>58.48556349897116</c:v>
                </c:pt>
                <c:pt idx="35">
                  <c:v>86.934729987528016</c:v>
                </c:pt>
                <c:pt idx="36">
                  <c:v>119.11293190061289</c:v>
                </c:pt>
              </c:numCache>
            </c:numRef>
          </c:val>
        </c:ser>
        <c:ser>
          <c:idx val="1"/>
          <c:order val="1"/>
          <c:tx>
            <c:strRef>
              <c:f>'C:\Users\Soham\Desktop\5th yr project\Abundance per million\[Segregation_flower.xlsx]Sheet3'!$D$8</c:f>
              <c:strCache>
                <c:ptCount val="1"/>
                <c:pt idx="0">
                  <c:v>UCGCUUGGUGCAGGUCGGGAA</c:v>
                </c:pt>
              </c:strCache>
            </c:strRef>
          </c:tx>
          <c:spPr>
            <a:solidFill>
              <a:srgbClr val="C00000"/>
            </a:solidFill>
          </c:spPr>
          <c:invertIfNegative val="0"/>
          <c:cat>
            <c:strRef>
              <c:f>'C:\Users\Soham\Desktop\5th yr project\Abundance per million\[Segregation_flower.xlsx]Sheet3'!$B$9:$B$45</c:f>
              <c:strCache>
                <c:ptCount val="37"/>
                <c:pt idx="0">
                  <c:v>ppa</c:v>
                </c:pt>
                <c:pt idx="1">
                  <c:v>sma</c:v>
                </c:pt>
                <c:pt idx="2">
                  <c:v>mqu</c:v>
                </c:pt>
                <c:pt idx="3">
                  <c:v>cru</c:v>
                </c:pt>
                <c:pt idx="4">
                  <c:v>gbi (f)</c:v>
                </c:pt>
                <c:pt idx="5">
                  <c:v>gbi (m)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r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gma</c:v>
                </c:pt>
                <c:pt idx="28">
                  <c:v>pvu</c:v>
                </c:pt>
                <c:pt idx="29">
                  <c:v>sla</c:v>
                </c:pt>
                <c:pt idx="30">
                  <c:v>lsa</c:v>
                </c:pt>
                <c:pt idx="31">
                  <c:v>mgu</c:v>
                </c:pt>
                <c:pt idx="32">
                  <c:v>nta</c:v>
                </c:pt>
                <c:pt idx="33">
                  <c:v>phy</c:v>
                </c:pt>
                <c:pt idx="34">
                  <c:v>can</c:v>
                </c:pt>
                <c:pt idx="35">
                  <c:v>sly</c:v>
                </c:pt>
                <c:pt idx="36">
                  <c:v>stu</c:v>
                </c:pt>
              </c:strCache>
            </c:strRef>
          </c:cat>
          <c:val>
            <c:numRef>
              <c:f>'C:\Users\Soham\Desktop\5th yr project\Abundance per million\[Segregation_flower.xlsx]Sheet3'!$D$9:$D$45</c:f>
              <c:numCache>
                <c:formatCode>General</c:formatCode>
                <c:ptCount val="37"/>
                <c:pt idx="0">
                  <c:v>0</c:v>
                </c:pt>
                <c:pt idx="1">
                  <c:v>0</c:v>
                </c:pt>
                <c:pt idx="2">
                  <c:v>14572.581476284477</c:v>
                </c:pt>
                <c:pt idx="3">
                  <c:v>341.47897455716924</c:v>
                </c:pt>
                <c:pt idx="4">
                  <c:v>239.85923484904086</c:v>
                </c:pt>
                <c:pt idx="5">
                  <c:v>431.79025485713589</c:v>
                </c:pt>
                <c:pt idx="6">
                  <c:v>636.40817981628652</c:v>
                </c:pt>
                <c:pt idx="7">
                  <c:v>2191.3754961850618</c:v>
                </c:pt>
                <c:pt idx="8">
                  <c:v>757.21708420238929</c:v>
                </c:pt>
                <c:pt idx="9">
                  <c:v>904.75651714794628</c:v>
                </c:pt>
                <c:pt idx="10">
                  <c:v>11.141978518265416</c:v>
                </c:pt>
                <c:pt idx="11">
                  <c:v>2640.7558084761645</c:v>
                </c:pt>
                <c:pt idx="12">
                  <c:v>1.8004047309835249</c:v>
                </c:pt>
                <c:pt idx="13">
                  <c:v>69.568331944262681</c:v>
                </c:pt>
                <c:pt idx="20">
                  <c:v>1931.4530891274076</c:v>
                </c:pt>
                <c:pt idx="21">
                  <c:v>4129.4960161926592</c:v>
                </c:pt>
                <c:pt idx="22">
                  <c:v>2153.8590496524489</c:v>
                </c:pt>
                <c:pt idx="23">
                  <c:v>2773.6134741193905</c:v>
                </c:pt>
                <c:pt idx="25">
                  <c:v>25.256918992641818</c:v>
                </c:pt>
                <c:pt idx="26">
                  <c:v>4347.1077721630345</c:v>
                </c:pt>
                <c:pt idx="27">
                  <c:v>5039.0279791212288</c:v>
                </c:pt>
                <c:pt idx="28">
                  <c:v>2843.267934885715</c:v>
                </c:pt>
                <c:pt idx="29">
                  <c:v>1377.5130895446914</c:v>
                </c:pt>
                <c:pt idx="30">
                  <c:v>1789.8760137969609</c:v>
                </c:pt>
                <c:pt idx="31">
                  <c:v>2914.2465822913232</c:v>
                </c:pt>
                <c:pt idx="32">
                  <c:v>292.43842884057818</c:v>
                </c:pt>
                <c:pt idx="33">
                  <c:v>1702.3365391640045</c:v>
                </c:pt>
                <c:pt idx="34">
                  <c:v>241.17433980489719</c:v>
                </c:pt>
                <c:pt idx="35">
                  <c:v>3.3996821782832183</c:v>
                </c:pt>
                <c:pt idx="36">
                  <c:v>1.7711960133920133</c:v>
                </c:pt>
              </c:numCache>
            </c:numRef>
          </c:val>
        </c:ser>
        <c:ser>
          <c:idx val="2"/>
          <c:order val="2"/>
          <c:tx>
            <c:strRef>
              <c:f>'C:\Users\Soham\Desktop\5th yr project\Abundance per million\[Segregation_flower.xlsx]Sheet3'!$E$8</c:f>
              <c:strCache>
                <c:ptCount val="1"/>
                <c:pt idx="0">
                  <c:v>UCGCUUGGUGCAGGUCGGGAC</c:v>
                </c:pt>
              </c:strCache>
            </c:strRef>
          </c:tx>
          <c:invertIfNegative val="0"/>
          <c:cat>
            <c:strRef>
              <c:f>'C:\Users\Soham\Desktop\5th yr project\Abundance per million\[Segregation_flower.xlsx]Sheet3'!$B$9:$B$45</c:f>
              <c:strCache>
                <c:ptCount val="37"/>
                <c:pt idx="0">
                  <c:v>ppa</c:v>
                </c:pt>
                <c:pt idx="1">
                  <c:v>sma</c:v>
                </c:pt>
                <c:pt idx="2">
                  <c:v>mqu</c:v>
                </c:pt>
                <c:pt idx="3">
                  <c:v>cru</c:v>
                </c:pt>
                <c:pt idx="4">
                  <c:v>gbi (f)</c:v>
                </c:pt>
                <c:pt idx="5">
                  <c:v>gbi (m)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r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gma</c:v>
                </c:pt>
                <c:pt idx="28">
                  <c:v>pvu</c:v>
                </c:pt>
                <c:pt idx="29">
                  <c:v>sla</c:v>
                </c:pt>
                <c:pt idx="30">
                  <c:v>lsa</c:v>
                </c:pt>
                <c:pt idx="31">
                  <c:v>mgu</c:v>
                </c:pt>
                <c:pt idx="32">
                  <c:v>nta</c:v>
                </c:pt>
                <c:pt idx="33">
                  <c:v>phy</c:v>
                </c:pt>
                <c:pt idx="34">
                  <c:v>can</c:v>
                </c:pt>
                <c:pt idx="35">
                  <c:v>sly</c:v>
                </c:pt>
                <c:pt idx="36">
                  <c:v>stu</c:v>
                </c:pt>
              </c:strCache>
            </c:strRef>
          </c:cat>
          <c:val>
            <c:numRef>
              <c:f>'C:\Users\Soham\Desktop\5th yr project\Abundance per million\[Segregation_flower.xlsx]Sheet3'!$E$9:$E$45</c:f>
              <c:numCache>
                <c:formatCode>General</c:formatCode>
                <c:ptCount val="37"/>
                <c:pt idx="0">
                  <c:v>0</c:v>
                </c:pt>
                <c:pt idx="1">
                  <c:v>0</c:v>
                </c:pt>
                <c:pt idx="2">
                  <c:v>141.1119303002196</c:v>
                </c:pt>
                <c:pt idx="3">
                  <c:v>2.6471238337765057</c:v>
                </c:pt>
                <c:pt idx="4">
                  <c:v>3.5799885798364306</c:v>
                </c:pt>
                <c:pt idx="5">
                  <c:v>4.0354229425900554</c:v>
                </c:pt>
                <c:pt idx="6">
                  <c:v>1.8773102649447979</c:v>
                </c:pt>
                <c:pt idx="7">
                  <c:v>6.9457226503488485</c:v>
                </c:pt>
                <c:pt idx="8">
                  <c:v>24.839129004650939</c:v>
                </c:pt>
                <c:pt idx="9">
                  <c:v>1.8131393129217361</c:v>
                </c:pt>
                <c:pt idx="10">
                  <c:v>3.7139928394218056</c:v>
                </c:pt>
                <c:pt idx="11">
                  <c:v>25.889762828197689</c:v>
                </c:pt>
                <c:pt idx="12">
                  <c:v>6.6014840136062585</c:v>
                </c:pt>
                <c:pt idx="13">
                  <c:v>23.419042436682485</c:v>
                </c:pt>
                <c:pt idx="14">
                  <c:v>4.7241849063151182</c:v>
                </c:pt>
                <c:pt idx="15">
                  <c:v>6.691257036274977</c:v>
                </c:pt>
                <c:pt idx="16">
                  <c:v>4.8589469778454104</c:v>
                </c:pt>
                <c:pt idx="17">
                  <c:v>20.212960968772371</c:v>
                </c:pt>
                <c:pt idx="18">
                  <c:v>2.6615582492003678</c:v>
                </c:pt>
                <c:pt idx="19">
                  <c:v>9.758736704209177</c:v>
                </c:pt>
                <c:pt idx="20">
                  <c:v>23.950702610968737</c:v>
                </c:pt>
                <c:pt idx="21">
                  <c:v>150.6392621080727</c:v>
                </c:pt>
                <c:pt idx="22">
                  <c:v>38.539191226167723</c:v>
                </c:pt>
                <c:pt idx="23">
                  <c:v>2.4965017768851396</c:v>
                </c:pt>
                <c:pt idx="25">
                  <c:v>23.85375682638394</c:v>
                </c:pt>
                <c:pt idx="26">
                  <c:v>239.10486944386159</c:v>
                </c:pt>
                <c:pt idx="27">
                  <c:v>18.501830592885721</c:v>
                </c:pt>
                <c:pt idx="28">
                  <c:v>11.087266643835111</c:v>
                </c:pt>
                <c:pt idx="29">
                  <c:v>61.02906092919519</c:v>
                </c:pt>
                <c:pt idx="30">
                  <c:v>109.07056959075231</c:v>
                </c:pt>
                <c:pt idx="31">
                  <c:v>8.1162655033352777</c:v>
                </c:pt>
                <c:pt idx="32">
                  <c:v>1605.5513250892868</c:v>
                </c:pt>
                <c:pt idx="33">
                  <c:v>23456.259399982973</c:v>
                </c:pt>
                <c:pt idx="34">
                  <c:v>1357.7455010137498</c:v>
                </c:pt>
                <c:pt idx="35">
                  <c:v>749.87275475275567</c:v>
                </c:pt>
                <c:pt idx="36">
                  <c:v>4232.2728740002158</c:v>
                </c:pt>
              </c:numCache>
            </c:numRef>
          </c:val>
        </c:ser>
        <c:ser>
          <c:idx val="3"/>
          <c:order val="3"/>
          <c:tx>
            <c:strRef>
              <c:f>'C:\Users\Soham\Desktop\5th yr project\Abundance per million\[Segregation_flower.xlsx]Sheet3'!$F$8</c:f>
              <c:strCache>
                <c:ptCount val="1"/>
                <c:pt idx="0">
                  <c:v>UCGCUUGGUGCAGGUCGGGCA</c:v>
                </c:pt>
              </c:strCache>
            </c:strRef>
          </c:tx>
          <c:invertIfNegative val="0"/>
          <c:cat>
            <c:strRef>
              <c:f>'C:\Users\Soham\Desktop\5th yr project\Abundance per million\[Segregation_flower.xlsx]Sheet3'!$B$9:$B$45</c:f>
              <c:strCache>
                <c:ptCount val="37"/>
                <c:pt idx="0">
                  <c:v>ppa</c:v>
                </c:pt>
                <c:pt idx="1">
                  <c:v>sma</c:v>
                </c:pt>
                <c:pt idx="2">
                  <c:v>mqu</c:v>
                </c:pt>
                <c:pt idx="3">
                  <c:v>cru</c:v>
                </c:pt>
                <c:pt idx="4">
                  <c:v>gbi (f)</c:v>
                </c:pt>
                <c:pt idx="5">
                  <c:v>gbi (m)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r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gma</c:v>
                </c:pt>
                <c:pt idx="28">
                  <c:v>pvu</c:v>
                </c:pt>
                <c:pt idx="29">
                  <c:v>sla</c:v>
                </c:pt>
                <c:pt idx="30">
                  <c:v>lsa</c:v>
                </c:pt>
                <c:pt idx="31">
                  <c:v>mgu</c:v>
                </c:pt>
                <c:pt idx="32">
                  <c:v>nta</c:v>
                </c:pt>
                <c:pt idx="33">
                  <c:v>phy</c:v>
                </c:pt>
                <c:pt idx="34">
                  <c:v>can</c:v>
                </c:pt>
                <c:pt idx="35">
                  <c:v>sly</c:v>
                </c:pt>
                <c:pt idx="36">
                  <c:v>stu</c:v>
                </c:pt>
              </c:strCache>
            </c:strRef>
          </c:cat>
          <c:val>
            <c:numRef>
              <c:f>'C:\Users\Soham\Desktop\5th yr project\Abundance per million\[Segregation_flower.xlsx]Sheet3'!$F$9:$F$45</c:f>
              <c:numCache>
                <c:formatCode>General</c:formatCode>
                <c:ptCount val="37"/>
                <c:pt idx="0">
                  <c:v>0</c:v>
                </c:pt>
                <c:pt idx="1">
                  <c:v>0</c:v>
                </c:pt>
                <c:pt idx="2">
                  <c:v>325.0330978825283</c:v>
                </c:pt>
                <c:pt idx="21">
                  <c:v>252.47989001212184</c:v>
                </c:pt>
                <c:pt idx="26">
                  <c:v>457.99387529042878</c:v>
                </c:pt>
                <c:pt idx="29">
                  <c:v>110.96192896217308</c:v>
                </c:pt>
                <c:pt idx="30">
                  <c:v>233.056772629813</c:v>
                </c:pt>
              </c:numCache>
            </c:numRef>
          </c:val>
        </c:ser>
        <c:ser>
          <c:idx val="4"/>
          <c:order val="4"/>
          <c:tx>
            <c:strRef>
              <c:f>'C:\Users\Soham\Desktop\5th yr project\Abundance per million\[Segregation_flower.xlsx]Sheet3'!$G$8</c:f>
              <c:strCache>
                <c:ptCount val="1"/>
                <c:pt idx="0">
                  <c:v>UCGCUUGGUGCAGGUCGGGAU</c:v>
                </c:pt>
              </c:strCache>
            </c:strRef>
          </c:tx>
          <c:invertIfNegative val="0"/>
          <c:cat>
            <c:strRef>
              <c:f>'C:\Users\Soham\Desktop\5th yr project\Abundance per million\[Segregation_flower.xlsx]Sheet3'!$B$9:$B$45</c:f>
              <c:strCache>
                <c:ptCount val="37"/>
                <c:pt idx="0">
                  <c:v>ppa</c:v>
                </c:pt>
                <c:pt idx="1">
                  <c:v>sma</c:v>
                </c:pt>
                <c:pt idx="2">
                  <c:v>mqu</c:v>
                </c:pt>
                <c:pt idx="3">
                  <c:v>cru</c:v>
                </c:pt>
                <c:pt idx="4">
                  <c:v>gbi (f)</c:v>
                </c:pt>
                <c:pt idx="5">
                  <c:v>gbi (m)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r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gma</c:v>
                </c:pt>
                <c:pt idx="28">
                  <c:v>pvu</c:v>
                </c:pt>
                <c:pt idx="29">
                  <c:v>sla</c:v>
                </c:pt>
                <c:pt idx="30">
                  <c:v>lsa</c:v>
                </c:pt>
                <c:pt idx="31">
                  <c:v>mgu</c:v>
                </c:pt>
                <c:pt idx="32">
                  <c:v>nta</c:v>
                </c:pt>
                <c:pt idx="33">
                  <c:v>phy</c:v>
                </c:pt>
                <c:pt idx="34">
                  <c:v>can</c:v>
                </c:pt>
                <c:pt idx="35">
                  <c:v>sly</c:v>
                </c:pt>
                <c:pt idx="36">
                  <c:v>stu</c:v>
                </c:pt>
              </c:strCache>
            </c:strRef>
          </c:cat>
          <c:val>
            <c:numRef>
              <c:f>'C:\Users\Soham\Desktop\5th yr project\Abundance per million\[Segregation_flower.xlsx]Sheet3'!$G$9:$G$45</c:f>
              <c:numCache>
                <c:formatCode>General</c:formatCode>
                <c:ptCount val="37"/>
                <c:pt idx="0">
                  <c:v>0</c:v>
                </c:pt>
                <c:pt idx="1">
                  <c:v>0</c:v>
                </c:pt>
                <c:pt idx="2">
                  <c:v>247.34225985207033</c:v>
                </c:pt>
                <c:pt idx="21">
                  <c:v>70.722658266700805</c:v>
                </c:pt>
                <c:pt idx="23">
                  <c:v>40.880216596494165</c:v>
                </c:pt>
                <c:pt idx="25">
                  <c:v>131.19566254511167</c:v>
                </c:pt>
                <c:pt idx="26">
                  <c:v>97.593824262800652</c:v>
                </c:pt>
                <c:pt idx="33">
                  <c:v>87.245124989962278</c:v>
                </c:pt>
              </c:numCache>
            </c:numRef>
          </c:val>
        </c:ser>
        <c:ser>
          <c:idx val="5"/>
          <c:order val="5"/>
          <c:tx>
            <c:strRef>
              <c:f>'C:\Users\Soham\Desktop\5th yr project\Abundance per million\[Segregation_flower.xlsx]Sheet3'!$H$8</c:f>
              <c:strCache>
                <c:ptCount val="1"/>
                <c:pt idx="0">
                  <c:v>UCGCUUGGUGCAGAUCGGGCC</c:v>
                </c:pt>
              </c:strCache>
            </c:strRef>
          </c:tx>
          <c:invertIfNegative val="0"/>
          <c:cat>
            <c:strRef>
              <c:f>'C:\Users\Soham\Desktop\5th yr project\Abundance per million\[Segregation_flower.xlsx]Sheet3'!$B$9:$B$45</c:f>
              <c:strCache>
                <c:ptCount val="37"/>
                <c:pt idx="0">
                  <c:v>ppa</c:v>
                </c:pt>
                <c:pt idx="1">
                  <c:v>sma</c:v>
                </c:pt>
                <c:pt idx="2">
                  <c:v>mqu</c:v>
                </c:pt>
                <c:pt idx="3">
                  <c:v>cru</c:v>
                </c:pt>
                <c:pt idx="4">
                  <c:v>gbi (f)</c:v>
                </c:pt>
                <c:pt idx="5">
                  <c:v>gbi (m)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r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gma</c:v>
                </c:pt>
                <c:pt idx="28">
                  <c:v>pvu</c:v>
                </c:pt>
                <c:pt idx="29">
                  <c:v>sla</c:v>
                </c:pt>
                <c:pt idx="30">
                  <c:v>lsa</c:v>
                </c:pt>
                <c:pt idx="31">
                  <c:v>mgu</c:v>
                </c:pt>
                <c:pt idx="32">
                  <c:v>nta</c:v>
                </c:pt>
                <c:pt idx="33">
                  <c:v>phy</c:v>
                </c:pt>
                <c:pt idx="34">
                  <c:v>can</c:v>
                </c:pt>
                <c:pt idx="35">
                  <c:v>sly</c:v>
                </c:pt>
                <c:pt idx="36">
                  <c:v>stu</c:v>
                </c:pt>
              </c:strCache>
            </c:strRef>
          </c:cat>
          <c:val>
            <c:numRef>
              <c:f>'C:\Users\Soham\Desktop\5th yr project\Abundance per million\[Segregation_flower.xlsx]Sheet3'!$H$9:$H$45</c:f>
              <c:numCache>
                <c:formatCode>General</c:formatCode>
                <c:ptCount val="37"/>
                <c:pt idx="0">
                  <c:v>0</c:v>
                </c:pt>
                <c:pt idx="1">
                  <c:v>0</c:v>
                </c:pt>
                <c:pt idx="14">
                  <c:v>88.041627799509016</c:v>
                </c:pt>
                <c:pt idx="16">
                  <c:v>60.515975996801927</c:v>
                </c:pt>
                <c:pt idx="17">
                  <c:v>368.01528936247598</c:v>
                </c:pt>
              </c:numCache>
            </c:numRef>
          </c:val>
        </c:ser>
        <c:ser>
          <c:idx val="6"/>
          <c:order val="6"/>
          <c:tx>
            <c:strRef>
              <c:f>'C:\Users\Soham\Desktop\5th yr project\Abundance per million\[Segregation_flower.xlsx]Sheet3'!$I$8</c:f>
              <c:strCache>
                <c:ptCount val="1"/>
                <c:pt idx="0">
                  <c:v>UCGCUUGGUGCAGAUCGGGAU</c:v>
                </c:pt>
              </c:strCache>
            </c:strRef>
          </c:tx>
          <c:invertIfNegative val="0"/>
          <c:cat>
            <c:strRef>
              <c:f>'C:\Users\Soham\Desktop\5th yr project\Abundance per million\[Segregation_flower.xlsx]Sheet3'!$B$9:$B$45</c:f>
              <c:strCache>
                <c:ptCount val="37"/>
                <c:pt idx="0">
                  <c:v>ppa</c:v>
                </c:pt>
                <c:pt idx="1">
                  <c:v>sma</c:v>
                </c:pt>
                <c:pt idx="2">
                  <c:v>mqu</c:v>
                </c:pt>
                <c:pt idx="3">
                  <c:v>cru</c:v>
                </c:pt>
                <c:pt idx="4">
                  <c:v>gbi (f)</c:v>
                </c:pt>
                <c:pt idx="5">
                  <c:v>gbi (m)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r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gma</c:v>
                </c:pt>
                <c:pt idx="28">
                  <c:v>pvu</c:v>
                </c:pt>
                <c:pt idx="29">
                  <c:v>sla</c:v>
                </c:pt>
                <c:pt idx="30">
                  <c:v>lsa</c:v>
                </c:pt>
                <c:pt idx="31">
                  <c:v>mgu</c:v>
                </c:pt>
                <c:pt idx="32">
                  <c:v>nta</c:v>
                </c:pt>
                <c:pt idx="33">
                  <c:v>phy</c:v>
                </c:pt>
                <c:pt idx="34">
                  <c:v>can</c:v>
                </c:pt>
                <c:pt idx="35">
                  <c:v>sly</c:v>
                </c:pt>
                <c:pt idx="36">
                  <c:v>stu</c:v>
                </c:pt>
              </c:strCache>
            </c:strRef>
          </c:cat>
          <c:val>
            <c:numRef>
              <c:f>'C:\Users\Soham\Desktop\5th yr project\Abundance per million\[Segregation_flower.xlsx]Sheet3'!$I$9:$I$45</c:f>
              <c:numCache>
                <c:formatCode>General</c:formatCode>
                <c:ptCount val="37"/>
                <c:pt idx="0">
                  <c:v>0</c:v>
                </c:pt>
                <c:pt idx="1">
                  <c:v>0</c:v>
                </c:pt>
                <c:pt idx="13">
                  <c:v>139.13666388852536</c:v>
                </c:pt>
                <c:pt idx="19">
                  <c:v>49.574382457382619</c:v>
                </c:pt>
              </c:numCache>
            </c:numRef>
          </c:val>
        </c:ser>
        <c:ser>
          <c:idx val="7"/>
          <c:order val="7"/>
          <c:tx>
            <c:strRef>
              <c:f>'C:\Users\Soham\Desktop\5th yr project\Abundance per million\[Segregation_flower.xlsx]Sheet3'!$J$8</c:f>
              <c:strCache>
                <c:ptCount val="1"/>
                <c:pt idx="0">
                  <c:v>UCGAUUGGUGCAGAUCGGGAA</c:v>
                </c:pt>
              </c:strCache>
            </c:strRef>
          </c:tx>
          <c:invertIfNegative val="0"/>
          <c:cat>
            <c:strRef>
              <c:f>'C:\Users\Soham\Desktop\5th yr project\Abundance per million\[Segregation_flower.xlsx]Sheet3'!$B$9:$B$45</c:f>
              <c:strCache>
                <c:ptCount val="37"/>
                <c:pt idx="0">
                  <c:v>ppa</c:v>
                </c:pt>
                <c:pt idx="1">
                  <c:v>sma</c:v>
                </c:pt>
                <c:pt idx="2">
                  <c:v>mqu</c:v>
                </c:pt>
                <c:pt idx="3">
                  <c:v>cru</c:v>
                </c:pt>
                <c:pt idx="4">
                  <c:v>gbi (f)</c:v>
                </c:pt>
                <c:pt idx="5">
                  <c:v>gbi (m)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r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gma</c:v>
                </c:pt>
                <c:pt idx="28">
                  <c:v>pvu</c:v>
                </c:pt>
                <c:pt idx="29">
                  <c:v>sla</c:v>
                </c:pt>
                <c:pt idx="30">
                  <c:v>lsa</c:v>
                </c:pt>
                <c:pt idx="31">
                  <c:v>mgu</c:v>
                </c:pt>
                <c:pt idx="32">
                  <c:v>nta</c:v>
                </c:pt>
                <c:pt idx="33">
                  <c:v>phy</c:v>
                </c:pt>
                <c:pt idx="34">
                  <c:v>can</c:v>
                </c:pt>
                <c:pt idx="35">
                  <c:v>sly</c:v>
                </c:pt>
                <c:pt idx="36">
                  <c:v>stu</c:v>
                </c:pt>
              </c:strCache>
            </c:strRef>
          </c:cat>
          <c:val>
            <c:numRef>
              <c:f>'C:\Users\Soham\Desktop\5th yr project\Abundance per million\[Segregation_flower.xlsx]Sheet3'!$J$9:$J$45</c:f>
              <c:numCache>
                <c:formatCode>General</c:formatCode>
                <c:ptCount val="37"/>
                <c:pt idx="0">
                  <c:v>0</c:v>
                </c:pt>
                <c:pt idx="1">
                  <c:v>0</c:v>
                </c:pt>
                <c:pt idx="2">
                  <c:v>4.7565819202321213</c:v>
                </c:pt>
                <c:pt idx="6">
                  <c:v>1.8773102649447979</c:v>
                </c:pt>
                <c:pt idx="7">
                  <c:v>6.9457226503488485</c:v>
                </c:pt>
                <c:pt idx="9">
                  <c:v>0.72525572516869441</c:v>
                </c:pt>
                <c:pt idx="10">
                  <c:v>1357.4643828086701</c:v>
                </c:pt>
                <c:pt idx="11">
                  <c:v>1.4383201571220938</c:v>
                </c:pt>
                <c:pt idx="20">
                  <c:v>5.1322934166361582</c:v>
                </c:pt>
                <c:pt idx="21">
                  <c:v>11.315625322672128</c:v>
                </c:pt>
                <c:pt idx="22">
                  <c:v>1.9269595613083863</c:v>
                </c:pt>
                <c:pt idx="23">
                  <c:v>3.7447526653277099</c:v>
                </c:pt>
                <c:pt idx="25">
                  <c:v>11.315625322672128</c:v>
                </c:pt>
                <c:pt idx="26">
                  <c:v>2.0912962342028711</c:v>
                </c:pt>
                <c:pt idx="27">
                  <c:v>30.473603329458832</c:v>
                </c:pt>
                <c:pt idx="28">
                  <c:v>12.31918515981679</c:v>
                </c:pt>
                <c:pt idx="29">
                  <c:v>1.5851704137453295</c:v>
                </c:pt>
                <c:pt idx="30">
                  <c:v>0.93222709051925046</c:v>
                </c:pt>
                <c:pt idx="33">
                  <c:v>9.056587369200237</c:v>
                </c:pt>
                <c:pt idx="34">
                  <c:v>0.3144385134353288</c:v>
                </c:pt>
              </c:numCache>
            </c:numRef>
          </c:val>
        </c:ser>
        <c:ser>
          <c:idx val="8"/>
          <c:order val="8"/>
          <c:tx>
            <c:strRef>
              <c:f>'C:\Users\Soham\Desktop\5th yr project\Abundance per million\[Segregation_flower.xlsx]Sheet3'!$K$8</c:f>
              <c:strCache>
                <c:ptCount val="1"/>
                <c:pt idx="0">
                  <c:v>UCGCUUGGUACAGGUCGGGAA</c:v>
                </c:pt>
              </c:strCache>
            </c:strRef>
          </c:tx>
          <c:invertIfNegative val="0"/>
          <c:cat>
            <c:strRef>
              <c:f>'C:\Users\Soham\Desktop\5th yr project\Abundance per million\[Segregation_flower.xlsx]Sheet3'!$B$9:$B$45</c:f>
              <c:strCache>
                <c:ptCount val="37"/>
                <c:pt idx="0">
                  <c:v>ppa</c:v>
                </c:pt>
                <c:pt idx="1">
                  <c:v>sma</c:v>
                </c:pt>
                <c:pt idx="2">
                  <c:v>mqu</c:v>
                </c:pt>
                <c:pt idx="3">
                  <c:v>cru</c:v>
                </c:pt>
                <c:pt idx="4">
                  <c:v>gbi (f)</c:v>
                </c:pt>
                <c:pt idx="5">
                  <c:v>gbi (m)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r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gma</c:v>
                </c:pt>
                <c:pt idx="28">
                  <c:v>pvu</c:v>
                </c:pt>
                <c:pt idx="29">
                  <c:v>sla</c:v>
                </c:pt>
                <c:pt idx="30">
                  <c:v>lsa</c:v>
                </c:pt>
                <c:pt idx="31">
                  <c:v>mgu</c:v>
                </c:pt>
                <c:pt idx="32">
                  <c:v>nta</c:v>
                </c:pt>
                <c:pt idx="33">
                  <c:v>phy</c:v>
                </c:pt>
                <c:pt idx="34">
                  <c:v>can</c:v>
                </c:pt>
                <c:pt idx="35">
                  <c:v>sly</c:v>
                </c:pt>
                <c:pt idx="36">
                  <c:v>stu</c:v>
                </c:pt>
              </c:strCache>
            </c:strRef>
          </c:cat>
          <c:val>
            <c:numRef>
              <c:f>'C:\Users\Soham\Desktop\5th yr project\Abundance per million\[Segregation_flower.xlsx]Sheet3'!$K$9:$K$45</c:f>
              <c:numCache>
                <c:formatCode>General</c:formatCode>
                <c:ptCount val="37"/>
                <c:pt idx="0">
                  <c:v>0</c:v>
                </c:pt>
                <c:pt idx="1">
                  <c:v>0</c:v>
                </c:pt>
                <c:pt idx="2">
                  <c:v>6.3421092269761621</c:v>
                </c:pt>
                <c:pt idx="11">
                  <c:v>0.71916007856104691</c:v>
                </c:pt>
                <c:pt idx="23">
                  <c:v>1.2482508884425698</c:v>
                </c:pt>
                <c:pt idx="25">
                  <c:v>2.1047432493868183</c:v>
                </c:pt>
                <c:pt idx="26">
                  <c:v>1.3941974894685807</c:v>
                </c:pt>
                <c:pt idx="27">
                  <c:v>3.2650289281563034</c:v>
                </c:pt>
                <c:pt idx="30">
                  <c:v>691.71250116528392</c:v>
                </c:pt>
                <c:pt idx="31">
                  <c:v>1.5217997818753646</c:v>
                </c:pt>
                <c:pt idx="33">
                  <c:v>0.30188624564000788</c:v>
                </c:pt>
              </c:numCache>
            </c:numRef>
          </c:val>
        </c:ser>
        <c:ser>
          <c:idx val="9"/>
          <c:order val="9"/>
          <c:tx>
            <c:strRef>
              <c:f>'C:\Users\Soham\Desktop\5th yr project\Abundance per million\[Segregation_flower.xlsx]Sheet3'!$L$8</c:f>
              <c:strCache>
                <c:ptCount val="1"/>
                <c:pt idx="0">
                  <c:v>Rest</c:v>
                </c:pt>
              </c:strCache>
            </c:strRef>
          </c:tx>
          <c:invertIfNegative val="0"/>
          <c:cat>
            <c:strRef>
              <c:f>'C:\Users\Soham\Desktop\5th yr project\Abundance per million\[Segregation_flower.xlsx]Sheet3'!$B$9:$B$45</c:f>
              <c:strCache>
                <c:ptCount val="37"/>
                <c:pt idx="0">
                  <c:v>ppa</c:v>
                </c:pt>
                <c:pt idx="1">
                  <c:v>sma</c:v>
                </c:pt>
                <c:pt idx="2">
                  <c:v>mqu</c:v>
                </c:pt>
                <c:pt idx="3">
                  <c:v>cru</c:v>
                </c:pt>
                <c:pt idx="4">
                  <c:v>gbi (f)</c:v>
                </c:pt>
                <c:pt idx="5">
                  <c:v>gbi (m)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r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gma</c:v>
                </c:pt>
                <c:pt idx="28">
                  <c:v>pvu</c:v>
                </c:pt>
                <c:pt idx="29">
                  <c:v>sla</c:v>
                </c:pt>
                <c:pt idx="30">
                  <c:v>lsa</c:v>
                </c:pt>
                <c:pt idx="31">
                  <c:v>mgu</c:v>
                </c:pt>
                <c:pt idx="32">
                  <c:v>nta</c:v>
                </c:pt>
                <c:pt idx="33">
                  <c:v>phy</c:v>
                </c:pt>
                <c:pt idx="34">
                  <c:v>can</c:v>
                </c:pt>
                <c:pt idx="35">
                  <c:v>sly</c:v>
                </c:pt>
                <c:pt idx="36">
                  <c:v>stu</c:v>
                </c:pt>
              </c:strCache>
            </c:strRef>
          </c:cat>
          <c:val>
            <c:numRef>
              <c:f>'C:\Users\Soham\Desktop\5th yr project\Abundance per million\[Segregation_flower.xlsx]Sheet3'!$L$9:$L$45</c:f>
              <c:numCache>
                <c:formatCode>General</c:formatCode>
                <c:ptCount val="37"/>
                <c:pt idx="0">
                  <c:v>0</c:v>
                </c:pt>
                <c:pt idx="1">
                  <c:v>0</c:v>
                </c:pt>
                <c:pt idx="2">
                  <c:v>1861.4090581175035</c:v>
                </c:pt>
                <c:pt idx="3">
                  <c:v>395.74501314958763</c:v>
                </c:pt>
                <c:pt idx="4">
                  <c:v>814.447401912788</c:v>
                </c:pt>
                <c:pt idx="5">
                  <c:v>437.84338927102101</c:v>
                </c:pt>
                <c:pt idx="6">
                  <c:v>381.09398378379399</c:v>
                </c:pt>
                <c:pt idx="7">
                  <c:v>3129.0480539821565</c:v>
                </c:pt>
                <c:pt idx="8">
                  <c:v>546.46083810232062</c:v>
                </c:pt>
                <c:pt idx="9">
                  <c:v>129.0955190800276</c:v>
                </c:pt>
                <c:pt idx="10">
                  <c:v>531.10097603731822</c:v>
                </c:pt>
                <c:pt idx="11">
                  <c:v>589.71126442005846</c:v>
                </c:pt>
                <c:pt idx="12">
                  <c:v>617.53882272734904</c:v>
                </c:pt>
                <c:pt idx="13">
                  <c:v>4870.4720314641718</c:v>
                </c:pt>
                <c:pt idx="14">
                  <c:v>543.71073558135811</c:v>
                </c:pt>
                <c:pt idx="15">
                  <c:v>751.65120707488916</c:v>
                </c:pt>
                <c:pt idx="16">
                  <c:v>1115.7909150943187</c:v>
                </c:pt>
                <c:pt idx="17">
                  <c:v>782.03248989526207</c:v>
                </c:pt>
                <c:pt idx="18">
                  <c:v>465.10730404776427</c:v>
                </c:pt>
                <c:pt idx="19">
                  <c:v>3240.2909352656152</c:v>
                </c:pt>
                <c:pt idx="20">
                  <c:v>583.37068502430998</c:v>
                </c:pt>
                <c:pt idx="21">
                  <c:v>361.39278374284106</c:v>
                </c:pt>
                <c:pt idx="22">
                  <c:v>317.94832761588373</c:v>
                </c:pt>
                <c:pt idx="23">
                  <c:v>371.0425765895539</c:v>
                </c:pt>
                <c:pt idx="24">
                  <c:v>26.728391431946839</c:v>
                </c:pt>
                <c:pt idx="25">
                  <c:v>9154.2299726664005</c:v>
                </c:pt>
                <c:pt idx="26">
                  <c:v>472.63294892984885</c:v>
                </c:pt>
                <c:pt idx="27">
                  <c:v>629.06224015811449</c:v>
                </c:pt>
                <c:pt idx="28">
                  <c:v>389.28625105021058</c:v>
                </c:pt>
                <c:pt idx="29">
                  <c:v>389.1593365744784</c:v>
                </c:pt>
                <c:pt idx="30">
                  <c:v>474.50358907429853</c:v>
                </c:pt>
                <c:pt idx="31">
                  <c:v>1597.3825043751744</c:v>
                </c:pt>
                <c:pt idx="32">
                  <c:v>362.15174622922456</c:v>
                </c:pt>
                <c:pt idx="33">
                  <c:v>848.60223649406225</c:v>
                </c:pt>
                <c:pt idx="34">
                  <c:v>88.671660788762722</c:v>
                </c:pt>
                <c:pt idx="35">
                  <c:v>59.737272561262266</c:v>
                </c:pt>
                <c:pt idx="36">
                  <c:v>128.854509974268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2"/>
        <c:overlap val="100"/>
        <c:axId val="75591680"/>
        <c:axId val="75593216"/>
      </c:barChart>
      <c:catAx>
        <c:axId val="7559168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050"/>
            </a:pPr>
            <a:endParaRPr lang="en-US"/>
          </a:p>
        </c:txPr>
        <c:crossAx val="75593216"/>
        <c:crosses val="autoZero"/>
        <c:auto val="1"/>
        <c:lblAlgn val="ctr"/>
        <c:lblOffset val="100"/>
        <c:noMultiLvlLbl val="0"/>
      </c:catAx>
      <c:valAx>
        <c:axId val="75593216"/>
        <c:scaling>
          <c:orientation val="minMax"/>
          <c:max val="9000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7559168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58317137187119905"/>
          <c:y val="0.20205305607734048"/>
          <c:w val="0.39102698290762433"/>
          <c:h val="0.41498366921002344"/>
        </c:manualLayout>
      </c:layout>
      <c:overlay val="0"/>
      <c:spPr>
        <a:ln>
          <a:solidFill>
            <a:schemeClr val="tx1"/>
          </a:solidFill>
        </a:ln>
      </c:spPr>
      <c:txPr>
        <a:bodyPr/>
        <a:lstStyle/>
        <a:p>
          <a:pPr>
            <a:defRPr sz="10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1638206368782209E-2"/>
          <c:y val="0.18163595800524934"/>
          <c:w val="0.91604702273661576"/>
          <c:h val="0.67605511811023622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C:\Users\Soham\Desktop\5th yr project\Abundance per million\[Segregation_flower.xlsx]Sheet3'!$C$8</c:f>
              <c:strCache>
                <c:ptCount val="1"/>
                <c:pt idx="0">
                  <c:v>UCGCUUGGUGCAGAUCGGGAC</c:v>
                </c:pt>
              </c:strCache>
            </c:strRef>
          </c:tx>
          <c:invertIfNegative val="0"/>
          <c:cat>
            <c:strRef>
              <c:f>'C:\Users\Soham\Desktop\5th yr project\Abundance per million\[Segregation_flower.xlsx]Sheet3'!$B$9:$B$45</c:f>
              <c:strCache>
                <c:ptCount val="37"/>
                <c:pt idx="0">
                  <c:v>ppa</c:v>
                </c:pt>
                <c:pt idx="1">
                  <c:v>sma</c:v>
                </c:pt>
                <c:pt idx="2">
                  <c:v>mqu</c:v>
                </c:pt>
                <c:pt idx="3">
                  <c:v>cru</c:v>
                </c:pt>
                <c:pt idx="4">
                  <c:v>gbi (f)</c:v>
                </c:pt>
                <c:pt idx="5">
                  <c:v>gbi (m)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r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gma</c:v>
                </c:pt>
                <c:pt idx="28">
                  <c:v>pvu</c:v>
                </c:pt>
                <c:pt idx="29">
                  <c:v>sla</c:v>
                </c:pt>
                <c:pt idx="30">
                  <c:v>lsa</c:v>
                </c:pt>
                <c:pt idx="31">
                  <c:v>mgu</c:v>
                </c:pt>
                <c:pt idx="32">
                  <c:v>nta</c:v>
                </c:pt>
                <c:pt idx="33">
                  <c:v>phy</c:v>
                </c:pt>
                <c:pt idx="34">
                  <c:v>can</c:v>
                </c:pt>
                <c:pt idx="35">
                  <c:v>sly</c:v>
                </c:pt>
                <c:pt idx="36">
                  <c:v>stu</c:v>
                </c:pt>
              </c:strCache>
            </c:strRef>
          </c:cat>
          <c:val>
            <c:numRef>
              <c:f>'C:\Users\Soham\Desktop\5th yr project\Abundance per million\[Segregation_flower.xlsx]Sheet3'!$C$9:$C$45</c:f>
              <c:numCache>
                <c:formatCode>General</c:formatCode>
                <c:ptCount val="37"/>
                <c:pt idx="0">
                  <c:v>0</c:v>
                </c:pt>
                <c:pt idx="1">
                  <c:v>0</c:v>
                </c:pt>
                <c:pt idx="2">
                  <c:v>1052.7901316780428</c:v>
                </c:pt>
                <c:pt idx="3">
                  <c:v>2480.3550322485862</c:v>
                </c:pt>
                <c:pt idx="4">
                  <c:v>5625.9520532129509</c:v>
                </c:pt>
                <c:pt idx="5">
                  <c:v>4465.1954859758962</c:v>
                </c:pt>
                <c:pt idx="6">
                  <c:v>2123.2379096525665</c:v>
                </c:pt>
                <c:pt idx="7">
                  <c:v>378.54188444401228</c:v>
                </c:pt>
                <c:pt idx="8">
                  <c:v>3265.2164127932051</c:v>
                </c:pt>
                <c:pt idx="9">
                  <c:v>193.64327862004143</c:v>
                </c:pt>
                <c:pt idx="10">
                  <c:v>4105.8190839808058</c:v>
                </c:pt>
                <c:pt idx="11">
                  <c:v>1992.7925776926611</c:v>
                </c:pt>
                <c:pt idx="12">
                  <c:v>13147.155480552028</c:v>
                </c:pt>
                <c:pt idx="13">
                  <c:v>73265.785467795373</c:v>
                </c:pt>
                <c:pt idx="14">
                  <c:v>12404.850621273261</c:v>
                </c:pt>
                <c:pt idx="15">
                  <c:v>18913.953222537268</c:v>
                </c:pt>
                <c:pt idx="16">
                  <c:v>14523.392516779932</c:v>
                </c:pt>
                <c:pt idx="17">
                  <c:v>18342.216581179782</c:v>
                </c:pt>
                <c:pt idx="18">
                  <c:v>2780.6629808520843</c:v>
                </c:pt>
                <c:pt idx="19">
                  <c:v>49523.246677052564</c:v>
                </c:pt>
                <c:pt idx="20">
                  <c:v>3710.6481402279423</c:v>
                </c:pt>
                <c:pt idx="21">
                  <c:v>3.5361329133350399</c:v>
                </c:pt>
                <c:pt idx="22">
                  <c:v>572.30698970859066</c:v>
                </c:pt>
                <c:pt idx="23">
                  <c:v>692.15511764140501</c:v>
                </c:pt>
                <c:pt idx="24">
                  <c:v>10.691356572778737</c:v>
                </c:pt>
                <c:pt idx="25">
                  <c:v>4104.9509173874249</c:v>
                </c:pt>
                <c:pt idx="26">
                  <c:v>23.004258576231582</c:v>
                </c:pt>
                <c:pt idx="27">
                  <c:v>19.590173568937821</c:v>
                </c:pt>
                <c:pt idx="29">
                  <c:v>13.473948516835302</c:v>
                </c:pt>
                <c:pt idx="30">
                  <c:v>3.7289083620770018</c:v>
                </c:pt>
                <c:pt idx="31">
                  <c:v>11.667131661044463</c:v>
                </c:pt>
                <c:pt idx="32">
                  <c:v>124.41145872435355</c:v>
                </c:pt>
                <c:pt idx="33">
                  <c:v>8.7547011235602294</c:v>
                </c:pt>
                <c:pt idx="34">
                  <c:v>58.48556349897116</c:v>
                </c:pt>
                <c:pt idx="35">
                  <c:v>86.934729987528016</c:v>
                </c:pt>
                <c:pt idx="36">
                  <c:v>119.11293190061289</c:v>
                </c:pt>
              </c:numCache>
            </c:numRef>
          </c:val>
        </c:ser>
        <c:ser>
          <c:idx val="1"/>
          <c:order val="1"/>
          <c:tx>
            <c:strRef>
              <c:f>'C:\Users\Soham\Desktop\5th yr project\Abundance per million\[Segregation_flower.xlsx]Sheet3'!$D$8</c:f>
              <c:strCache>
                <c:ptCount val="1"/>
                <c:pt idx="0">
                  <c:v>UCGCUUGGUGCAGGUCGGGAA</c:v>
                </c:pt>
              </c:strCache>
            </c:strRef>
          </c:tx>
          <c:spPr>
            <a:solidFill>
              <a:srgbClr val="C00000"/>
            </a:solidFill>
          </c:spPr>
          <c:invertIfNegative val="0"/>
          <c:cat>
            <c:strRef>
              <c:f>'C:\Users\Soham\Desktop\5th yr project\Abundance per million\[Segregation_flower.xlsx]Sheet3'!$B$9:$B$45</c:f>
              <c:strCache>
                <c:ptCount val="37"/>
                <c:pt idx="0">
                  <c:v>ppa</c:v>
                </c:pt>
                <c:pt idx="1">
                  <c:v>sma</c:v>
                </c:pt>
                <c:pt idx="2">
                  <c:v>mqu</c:v>
                </c:pt>
                <c:pt idx="3">
                  <c:v>cru</c:v>
                </c:pt>
                <c:pt idx="4">
                  <c:v>gbi (f)</c:v>
                </c:pt>
                <c:pt idx="5">
                  <c:v>gbi (m)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r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gma</c:v>
                </c:pt>
                <c:pt idx="28">
                  <c:v>pvu</c:v>
                </c:pt>
                <c:pt idx="29">
                  <c:v>sla</c:v>
                </c:pt>
                <c:pt idx="30">
                  <c:v>lsa</c:v>
                </c:pt>
                <c:pt idx="31">
                  <c:v>mgu</c:v>
                </c:pt>
                <c:pt idx="32">
                  <c:v>nta</c:v>
                </c:pt>
                <c:pt idx="33">
                  <c:v>phy</c:v>
                </c:pt>
                <c:pt idx="34">
                  <c:v>can</c:v>
                </c:pt>
                <c:pt idx="35">
                  <c:v>sly</c:v>
                </c:pt>
                <c:pt idx="36">
                  <c:v>stu</c:v>
                </c:pt>
              </c:strCache>
            </c:strRef>
          </c:cat>
          <c:val>
            <c:numRef>
              <c:f>'C:\Users\Soham\Desktop\5th yr project\Abundance per million\[Segregation_flower.xlsx]Sheet3'!$D$9:$D$45</c:f>
              <c:numCache>
                <c:formatCode>General</c:formatCode>
                <c:ptCount val="37"/>
                <c:pt idx="0">
                  <c:v>0</c:v>
                </c:pt>
                <c:pt idx="1">
                  <c:v>0</c:v>
                </c:pt>
                <c:pt idx="2">
                  <c:v>14572.581476284477</c:v>
                </c:pt>
                <c:pt idx="3">
                  <c:v>341.47897455716924</c:v>
                </c:pt>
                <c:pt idx="4">
                  <c:v>239.85923484904086</c:v>
                </c:pt>
                <c:pt idx="5">
                  <c:v>431.79025485713589</c:v>
                </c:pt>
                <c:pt idx="6">
                  <c:v>636.40817981628652</c:v>
                </c:pt>
                <c:pt idx="7">
                  <c:v>2191.3754961850618</c:v>
                </c:pt>
                <c:pt idx="8">
                  <c:v>757.21708420238929</c:v>
                </c:pt>
                <c:pt idx="9">
                  <c:v>904.75651714794628</c:v>
                </c:pt>
                <c:pt idx="10">
                  <c:v>11.141978518265416</c:v>
                </c:pt>
                <c:pt idx="11">
                  <c:v>2640.7558084761645</c:v>
                </c:pt>
                <c:pt idx="12">
                  <c:v>1.8004047309835249</c:v>
                </c:pt>
                <c:pt idx="13">
                  <c:v>69.568331944262681</c:v>
                </c:pt>
                <c:pt idx="20">
                  <c:v>1931.4530891274076</c:v>
                </c:pt>
                <c:pt idx="21">
                  <c:v>4129.4960161926592</c:v>
                </c:pt>
                <c:pt idx="22">
                  <c:v>2153.8590496524489</c:v>
                </c:pt>
                <c:pt idx="23">
                  <c:v>2773.6134741193905</c:v>
                </c:pt>
                <c:pt idx="25">
                  <c:v>25.256918992641818</c:v>
                </c:pt>
                <c:pt idx="26">
                  <c:v>4347.1077721630345</c:v>
                </c:pt>
                <c:pt idx="27">
                  <c:v>5039.0279791212288</c:v>
                </c:pt>
                <c:pt idx="28">
                  <c:v>2843.267934885715</c:v>
                </c:pt>
                <c:pt idx="29">
                  <c:v>1377.5130895446914</c:v>
                </c:pt>
                <c:pt idx="30">
                  <c:v>1789.8760137969609</c:v>
                </c:pt>
                <c:pt idx="31">
                  <c:v>2914.2465822913232</c:v>
                </c:pt>
                <c:pt idx="32">
                  <c:v>292.43842884057818</c:v>
                </c:pt>
                <c:pt idx="33">
                  <c:v>1702.3365391640045</c:v>
                </c:pt>
                <c:pt idx="34">
                  <c:v>241.17433980489719</c:v>
                </c:pt>
                <c:pt idx="35">
                  <c:v>3.3996821782832183</c:v>
                </c:pt>
                <c:pt idx="36">
                  <c:v>1.7711960133920133</c:v>
                </c:pt>
              </c:numCache>
            </c:numRef>
          </c:val>
        </c:ser>
        <c:ser>
          <c:idx val="2"/>
          <c:order val="2"/>
          <c:tx>
            <c:strRef>
              <c:f>'C:\Users\Soham\Desktop\5th yr project\Abundance per million\[Segregation_flower.xlsx]Sheet3'!$E$8</c:f>
              <c:strCache>
                <c:ptCount val="1"/>
                <c:pt idx="0">
                  <c:v>UCGCUUGGUGCAGGUCGGGAC</c:v>
                </c:pt>
              </c:strCache>
            </c:strRef>
          </c:tx>
          <c:invertIfNegative val="0"/>
          <c:cat>
            <c:strRef>
              <c:f>'C:\Users\Soham\Desktop\5th yr project\Abundance per million\[Segregation_flower.xlsx]Sheet3'!$B$9:$B$45</c:f>
              <c:strCache>
                <c:ptCount val="37"/>
                <c:pt idx="0">
                  <c:v>ppa</c:v>
                </c:pt>
                <c:pt idx="1">
                  <c:v>sma</c:v>
                </c:pt>
                <c:pt idx="2">
                  <c:v>mqu</c:v>
                </c:pt>
                <c:pt idx="3">
                  <c:v>cru</c:v>
                </c:pt>
                <c:pt idx="4">
                  <c:v>gbi (f)</c:v>
                </c:pt>
                <c:pt idx="5">
                  <c:v>gbi (m)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r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gma</c:v>
                </c:pt>
                <c:pt idx="28">
                  <c:v>pvu</c:v>
                </c:pt>
                <c:pt idx="29">
                  <c:v>sla</c:v>
                </c:pt>
                <c:pt idx="30">
                  <c:v>lsa</c:v>
                </c:pt>
                <c:pt idx="31">
                  <c:v>mgu</c:v>
                </c:pt>
                <c:pt idx="32">
                  <c:v>nta</c:v>
                </c:pt>
                <c:pt idx="33">
                  <c:v>phy</c:v>
                </c:pt>
                <c:pt idx="34">
                  <c:v>can</c:v>
                </c:pt>
                <c:pt idx="35">
                  <c:v>sly</c:v>
                </c:pt>
                <c:pt idx="36">
                  <c:v>stu</c:v>
                </c:pt>
              </c:strCache>
            </c:strRef>
          </c:cat>
          <c:val>
            <c:numRef>
              <c:f>'C:\Users\Soham\Desktop\5th yr project\Abundance per million\[Segregation_flower.xlsx]Sheet3'!$E$9:$E$45</c:f>
              <c:numCache>
                <c:formatCode>General</c:formatCode>
                <c:ptCount val="37"/>
                <c:pt idx="0">
                  <c:v>0</c:v>
                </c:pt>
                <c:pt idx="1">
                  <c:v>0</c:v>
                </c:pt>
                <c:pt idx="2">
                  <c:v>141.1119303002196</c:v>
                </c:pt>
                <c:pt idx="3">
                  <c:v>2.6471238337765057</c:v>
                </c:pt>
                <c:pt idx="4">
                  <c:v>3.5799885798364306</c:v>
                </c:pt>
                <c:pt idx="5">
                  <c:v>4.0354229425900554</c:v>
                </c:pt>
                <c:pt idx="6">
                  <c:v>1.8773102649447979</c:v>
                </c:pt>
                <c:pt idx="7">
                  <c:v>6.9457226503488485</c:v>
                </c:pt>
                <c:pt idx="8">
                  <c:v>24.839129004650939</c:v>
                </c:pt>
                <c:pt idx="9">
                  <c:v>1.8131393129217361</c:v>
                </c:pt>
                <c:pt idx="10">
                  <c:v>3.7139928394218056</c:v>
                </c:pt>
                <c:pt idx="11">
                  <c:v>25.889762828197689</c:v>
                </c:pt>
                <c:pt idx="12">
                  <c:v>6.6014840136062585</c:v>
                </c:pt>
                <c:pt idx="13">
                  <c:v>23.419042436682485</c:v>
                </c:pt>
                <c:pt idx="14">
                  <c:v>4.7241849063151182</c:v>
                </c:pt>
                <c:pt idx="15">
                  <c:v>6.691257036274977</c:v>
                </c:pt>
                <c:pt idx="16">
                  <c:v>4.8589469778454104</c:v>
                </c:pt>
                <c:pt idx="17">
                  <c:v>20.212960968772371</c:v>
                </c:pt>
                <c:pt idx="18">
                  <c:v>2.6615582492003678</c:v>
                </c:pt>
                <c:pt idx="19">
                  <c:v>9.758736704209177</c:v>
                </c:pt>
                <c:pt idx="20">
                  <c:v>23.950702610968737</c:v>
                </c:pt>
                <c:pt idx="21">
                  <c:v>150.6392621080727</c:v>
                </c:pt>
                <c:pt idx="22">
                  <c:v>38.539191226167723</c:v>
                </c:pt>
                <c:pt idx="23">
                  <c:v>2.4965017768851396</c:v>
                </c:pt>
                <c:pt idx="25">
                  <c:v>23.85375682638394</c:v>
                </c:pt>
                <c:pt idx="26">
                  <c:v>239.10486944386159</c:v>
                </c:pt>
                <c:pt idx="27">
                  <c:v>18.501830592885721</c:v>
                </c:pt>
                <c:pt idx="28">
                  <c:v>11.087266643835111</c:v>
                </c:pt>
                <c:pt idx="29">
                  <c:v>61.02906092919519</c:v>
                </c:pt>
                <c:pt idx="30">
                  <c:v>109.07056959075231</c:v>
                </c:pt>
                <c:pt idx="31">
                  <c:v>8.1162655033352777</c:v>
                </c:pt>
                <c:pt idx="32">
                  <c:v>1605.5513250892868</c:v>
                </c:pt>
                <c:pt idx="33">
                  <c:v>23456.259399982973</c:v>
                </c:pt>
                <c:pt idx="34">
                  <c:v>1357.7455010137498</c:v>
                </c:pt>
                <c:pt idx="35">
                  <c:v>749.87275475275567</c:v>
                </c:pt>
                <c:pt idx="36">
                  <c:v>4232.2728740002158</c:v>
                </c:pt>
              </c:numCache>
            </c:numRef>
          </c:val>
        </c:ser>
        <c:ser>
          <c:idx val="3"/>
          <c:order val="3"/>
          <c:tx>
            <c:strRef>
              <c:f>'C:\Users\Soham\Desktop\5th yr project\Abundance per million\[Segregation_flower.xlsx]Sheet3'!$F$8</c:f>
              <c:strCache>
                <c:ptCount val="1"/>
                <c:pt idx="0">
                  <c:v>UCGCUUGGUGCAGGUCGGGCA</c:v>
                </c:pt>
              </c:strCache>
            </c:strRef>
          </c:tx>
          <c:invertIfNegative val="0"/>
          <c:cat>
            <c:strRef>
              <c:f>'C:\Users\Soham\Desktop\5th yr project\Abundance per million\[Segregation_flower.xlsx]Sheet3'!$B$9:$B$45</c:f>
              <c:strCache>
                <c:ptCount val="37"/>
                <c:pt idx="0">
                  <c:v>ppa</c:v>
                </c:pt>
                <c:pt idx="1">
                  <c:v>sma</c:v>
                </c:pt>
                <c:pt idx="2">
                  <c:v>mqu</c:v>
                </c:pt>
                <c:pt idx="3">
                  <c:v>cru</c:v>
                </c:pt>
                <c:pt idx="4">
                  <c:v>gbi (f)</c:v>
                </c:pt>
                <c:pt idx="5">
                  <c:v>gbi (m)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r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gma</c:v>
                </c:pt>
                <c:pt idx="28">
                  <c:v>pvu</c:v>
                </c:pt>
                <c:pt idx="29">
                  <c:v>sla</c:v>
                </c:pt>
                <c:pt idx="30">
                  <c:v>lsa</c:v>
                </c:pt>
                <c:pt idx="31">
                  <c:v>mgu</c:v>
                </c:pt>
                <c:pt idx="32">
                  <c:v>nta</c:v>
                </c:pt>
                <c:pt idx="33">
                  <c:v>phy</c:v>
                </c:pt>
                <c:pt idx="34">
                  <c:v>can</c:v>
                </c:pt>
                <c:pt idx="35">
                  <c:v>sly</c:v>
                </c:pt>
                <c:pt idx="36">
                  <c:v>stu</c:v>
                </c:pt>
              </c:strCache>
            </c:strRef>
          </c:cat>
          <c:val>
            <c:numRef>
              <c:f>'C:\Users\Soham\Desktop\5th yr project\Abundance per million\[Segregation_flower.xlsx]Sheet3'!$F$9:$F$45</c:f>
              <c:numCache>
                <c:formatCode>General</c:formatCode>
                <c:ptCount val="37"/>
                <c:pt idx="0">
                  <c:v>0</c:v>
                </c:pt>
                <c:pt idx="1">
                  <c:v>0</c:v>
                </c:pt>
                <c:pt idx="2">
                  <c:v>325.0330978825283</c:v>
                </c:pt>
                <c:pt idx="21">
                  <c:v>252.47989001212184</c:v>
                </c:pt>
                <c:pt idx="26">
                  <c:v>457.99387529042878</c:v>
                </c:pt>
                <c:pt idx="29">
                  <c:v>110.96192896217308</c:v>
                </c:pt>
                <c:pt idx="30">
                  <c:v>233.056772629813</c:v>
                </c:pt>
              </c:numCache>
            </c:numRef>
          </c:val>
        </c:ser>
        <c:ser>
          <c:idx val="4"/>
          <c:order val="4"/>
          <c:tx>
            <c:strRef>
              <c:f>'C:\Users\Soham\Desktop\5th yr project\Abundance per million\[Segregation_flower.xlsx]Sheet3'!$G$8</c:f>
              <c:strCache>
                <c:ptCount val="1"/>
                <c:pt idx="0">
                  <c:v>UCGCUUGGUGCAGGUCGGGAU</c:v>
                </c:pt>
              </c:strCache>
            </c:strRef>
          </c:tx>
          <c:invertIfNegative val="0"/>
          <c:cat>
            <c:strRef>
              <c:f>'C:\Users\Soham\Desktop\5th yr project\Abundance per million\[Segregation_flower.xlsx]Sheet3'!$B$9:$B$45</c:f>
              <c:strCache>
                <c:ptCount val="37"/>
                <c:pt idx="0">
                  <c:v>ppa</c:v>
                </c:pt>
                <c:pt idx="1">
                  <c:v>sma</c:v>
                </c:pt>
                <c:pt idx="2">
                  <c:v>mqu</c:v>
                </c:pt>
                <c:pt idx="3">
                  <c:v>cru</c:v>
                </c:pt>
                <c:pt idx="4">
                  <c:v>gbi (f)</c:v>
                </c:pt>
                <c:pt idx="5">
                  <c:v>gbi (m)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r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gma</c:v>
                </c:pt>
                <c:pt idx="28">
                  <c:v>pvu</c:v>
                </c:pt>
                <c:pt idx="29">
                  <c:v>sla</c:v>
                </c:pt>
                <c:pt idx="30">
                  <c:v>lsa</c:v>
                </c:pt>
                <c:pt idx="31">
                  <c:v>mgu</c:v>
                </c:pt>
                <c:pt idx="32">
                  <c:v>nta</c:v>
                </c:pt>
                <c:pt idx="33">
                  <c:v>phy</c:v>
                </c:pt>
                <c:pt idx="34">
                  <c:v>can</c:v>
                </c:pt>
                <c:pt idx="35">
                  <c:v>sly</c:v>
                </c:pt>
                <c:pt idx="36">
                  <c:v>stu</c:v>
                </c:pt>
              </c:strCache>
            </c:strRef>
          </c:cat>
          <c:val>
            <c:numRef>
              <c:f>'C:\Users\Soham\Desktop\5th yr project\Abundance per million\[Segregation_flower.xlsx]Sheet3'!$G$9:$G$45</c:f>
              <c:numCache>
                <c:formatCode>General</c:formatCode>
                <c:ptCount val="37"/>
                <c:pt idx="0">
                  <c:v>0</c:v>
                </c:pt>
                <c:pt idx="1">
                  <c:v>0</c:v>
                </c:pt>
                <c:pt idx="2">
                  <c:v>247.34225985207033</c:v>
                </c:pt>
                <c:pt idx="21">
                  <c:v>70.722658266700805</c:v>
                </c:pt>
                <c:pt idx="23">
                  <c:v>40.880216596494165</c:v>
                </c:pt>
                <c:pt idx="25">
                  <c:v>131.19566254511167</c:v>
                </c:pt>
                <c:pt idx="26">
                  <c:v>97.593824262800652</c:v>
                </c:pt>
                <c:pt idx="33">
                  <c:v>87.245124989962278</c:v>
                </c:pt>
              </c:numCache>
            </c:numRef>
          </c:val>
        </c:ser>
        <c:ser>
          <c:idx val="5"/>
          <c:order val="5"/>
          <c:tx>
            <c:strRef>
              <c:f>'C:\Users\Soham\Desktop\5th yr project\Abundance per million\[Segregation_flower.xlsx]Sheet3'!$H$8</c:f>
              <c:strCache>
                <c:ptCount val="1"/>
                <c:pt idx="0">
                  <c:v>UCGCUUGGUGCAGAUCGGGCC</c:v>
                </c:pt>
              </c:strCache>
            </c:strRef>
          </c:tx>
          <c:invertIfNegative val="0"/>
          <c:cat>
            <c:strRef>
              <c:f>'C:\Users\Soham\Desktop\5th yr project\Abundance per million\[Segregation_flower.xlsx]Sheet3'!$B$9:$B$45</c:f>
              <c:strCache>
                <c:ptCount val="37"/>
                <c:pt idx="0">
                  <c:v>ppa</c:v>
                </c:pt>
                <c:pt idx="1">
                  <c:v>sma</c:v>
                </c:pt>
                <c:pt idx="2">
                  <c:v>mqu</c:v>
                </c:pt>
                <c:pt idx="3">
                  <c:v>cru</c:v>
                </c:pt>
                <c:pt idx="4">
                  <c:v>gbi (f)</c:v>
                </c:pt>
                <c:pt idx="5">
                  <c:v>gbi (m)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r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gma</c:v>
                </c:pt>
                <c:pt idx="28">
                  <c:v>pvu</c:v>
                </c:pt>
                <c:pt idx="29">
                  <c:v>sla</c:v>
                </c:pt>
                <c:pt idx="30">
                  <c:v>lsa</c:v>
                </c:pt>
                <c:pt idx="31">
                  <c:v>mgu</c:v>
                </c:pt>
                <c:pt idx="32">
                  <c:v>nta</c:v>
                </c:pt>
                <c:pt idx="33">
                  <c:v>phy</c:v>
                </c:pt>
                <c:pt idx="34">
                  <c:v>can</c:v>
                </c:pt>
                <c:pt idx="35">
                  <c:v>sly</c:v>
                </c:pt>
                <c:pt idx="36">
                  <c:v>stu</c:v>
                </c:pt>
              </c:strCache>
            </c:strRef>
          </c:cat>
          <c:val>
            <c:numRef>
              <c:f>'C:\Users\Soham\Desktop\5th yr project\Abundance per million\[Segregation_flower.xlsx]Sheet3'!$H$9:$H$45</c:f>
              <c:numCache>
                <c:formatCode>General</c:formatCode>
                <c:ptCount val="37"/>
                <c:pt idx="0">
                  <c:v>0</c:v>
                </c:pt>
                <c:pt idx="1">
                  <c:v>0</c:v>
                </c:pt>
                <c:pt idx="14">
                  <c:v>88.041627799509016</c:v>
                </c:pt>
                <c:pt idx="16">
                  <c:v>60.515975996801927</c:v>
                </c:pt>
                <c:pt idx="17">
                  <c:v>368.01528936247598</c:v>
                </c:pt>
              </c:numCache>
            </c:numRef>
          </c:val>
        </c:ser>
        <c:ser>
          <c:idx val="6"/>
          <c:order val="6"/>
          <c:tx>
            <c:strRef>
              <c:f>'C:\Users\Soham\Desktop\5th yr project\Abundance per million\[Segregation_flower.xlsx]Sheet3'!$I$8</c:f>
              <c:strCache>
                <c:ptCount val="1"/>
                <c:pt idx="0">
                  <c:v>UCGCUUGGUGCAGAUCGGGAU</c:v>
                </c:pt>
              </c:strCache>
            </c:strRef>
          </c:tx>
          <c:invertIfNegative val="0"/>
          <c:cat>
            <c:strRef>
              <c:f>'C:\Users\Soham\Desktop\5th yr project\Abundance per million\[Segregation_flower.xlsx]Sheet3'!$B$9:$B$45</c:f>
              <c:strCache>
                <c:ptCount val="37"/>
                <c:pt idx="0">
                  <c:v>ppa</c:v>
                </c:pt>
                <c:pt idx="1">
                  <c:v>sma</c:v>
                </c:pt>
                <c:pt idx="2">
                  <c:v>mqu</c:v>
                </c:pt>
                <c:pt idx="3">
                  <c:v>cru</c:v>
                </c:pt>
                <c:pt idx="4">
                  <c:v>gbi (f)</c:v>
                </c:pt>
                <c:pt idx="5">
                  <c:v>gbi (m)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r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gma</c:v>
                </c:pt>
                <c:pt idx="28">
                  <c:v>pvu</c:v>
                </c:pt>
                <c:pt idx="29">
                  <c:v>sla</c:v>
                </c:pt>
                <c:pt idx="30">
                  <c:v>lsa</c:v>
                </c:pt>
                <c:pt idx="31">
                  <c:v>mgu</c:v>
                </c:pt>
                <c:pt idx="32">
                  <c:v>nta</c:v>
                </c:pt>
                <c:pt idx="33">
                  <c:v>phy</c:v>
                </c:pt>
                <c:pt idx="34">
                  <c:v>can</c:v>
                </c:pt>
                <c:pt idx="35">
                  <c:v>sly</c:v>
                </c:pt>
                <c:pt idx="36">
                  <c:v>stu</c:v>
                </c:pt>
              </c:strCache>
            </c:strRef>
          </c:cat>
          <c:val>
            <c:numRef>
              <c:f>'C:\Users\Soham\Desktop\5th yr project\Abundance per million\[Segregation_flower.xlsx]Sheet3'!$I$9:$I$45</c:f>
              <c:numCache>
                <c:formatCode>General</c:formatCode>
                <c:ptCount val="37"/>
                <c:pt idx="0">
                  <c:v>0</c:v>
                </c:pt>
                <c:pt idx="1">
                  <c:v>0</c:v>
                </c:pt>
                <c:pt idx="13">
                  <c:v>139.13666388852536</c:v>
                </c:pt>
                <c:pt idx="19">
                  <c:v>49.574382457382619</c:v>
                </c:pt>
              </c:numCache>
            </c:numRef>
          </c:val>
        </c:ser>
        <c:ser>
          <c:idx val="7"/>
          <c:order val="7"/>
          <c:tx>
            <c:strRef>
              <c:f>'C:\Users\Soham\Desktop\5th yr project\Abundance per million\[Segregation_flower.xlsx]Sheet3'!$J$8</c:f>
              <c:strCache>
                <c:ptCount val="1"/>
                <c:pt idx="0">
                  <c:v>UCGAUUGGUGCAGAUCGGGAA</c:v>
                </c:pt>
              </c:strCache>
            </c:strRef>
          </c:tx>
          <c:invertIfNegative val="0"/>
          <c:cat>
            <c:strRef>
              <c:f>'C:\Users\Soham\Desktop\5th yr project\Abundance per million\[Segregation_flower.xlsx]Sheet3'!$B$9:$B$45</c:f>
              <c:strCache>
                <c:ptCount val="37"/>
                <c:pt idx="0">
                  <c:v>ppa</c:v>
                </c:pt>
                <c:pt idx="1">
                  <c:v>sma</c:v>
                </c:pt>
                <c:pt idx="2">
                  <c:v>mqu</c:v>
                </c:pt>
                <c:pt idx="3">
                  <c:v>cru</c:v>
                </c:pt>
                <c:pt idx="4">
                  <c:v>gbi (f)</c:v>
                </c:pt>
                <c:pt idx="5">
                  <c:v>gbi (m)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r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gma</c:v>
                </c:pt>
                <c:pt idx="28">
                  <c:v>pvu</c:v>
                </c:pt>
                <c:pt idx="29">
                  <c:v>sla</c:v>
                </c:pt>
                <c:pt idx="30">
                  <c:v>lsa</c:v>
                </c:pt>
                <c:pt idx="31">
                  <c:v>mgu</c:v>
                </c:pt>
                <c:pt idx="32">
                  <c:v>nta</c:v>
                </c:pt>
                <c:pt idx="33">
                  <c:v>phy</c:v>
                </c:pt>
                <c:pt idx="34">
                  <c:v>can</c:v>
                </c:pt>
                <c:pt idx="35">
                  <c:v>sly</c:v>
                </c:pt>
                <c:pt idx="36">
                  <c:v>stu</c:v>
                </c:pt>
              </c:strCache>
            </c:strRef>
          </c:cat>
          <c:val>
            <c:numRef>
              <c:f>'C:\Users\Soham\Desktop\5th yr project\Abundance per million\[Segregation_flower.xlsx]Sheet3'!$J$9:$J$45</c:f>
              <c:numCache>
                <c:formatCode>General</c:formatCode>
                <c:ptCount val="37"/>
                <c:pt idx="0">
                  <c:v>0</c:v>
                </c:pt>
                <c:pt idx="1">
                  <c:v>0</c:v>
                </c:pt>
                <c:pt idx="2">
                  <c:v>4.7565819202321213</c:v>
                </c:pt>
                <c:pt idx="6">
                  <c:v>1.8773102649447979</c:v>
                </c:pt>
                <c:pt idx="7">
                  <c:v>6.9457226503488485</c:v>
                </c:pt>
                <c:pt idx="9">
                  <c:v>0.72525572516869441</c:v>
                </c:pt>
                <c:pt idx="10">
                  <c:v>1357.4643828086701</c:v>
                </c:pt>
                <c:pt idx="11">
                  <c:v>1.4383201571220938</c:v>
                </c:pt>
                <c:pt idx="20">
                  <c:v>5.1322934166361582</c:v>
                </c:pt>
                <c:pt idx="21">
                  <c:v>11.315625322672128</c:v>
                </c:pt>
                <c:pt idx="22">
                  <c:v>1.9269595613083863</c:v>
                </c:pt>
                <c:pt idx="23">
                  <c:v>3.7447526653277099</c:v>
                </c:pt>
                <c:pt idx="25">
                  <c:v>11.315625322672128</c:v>
                </c:pt>
                <c:pt idx="26">
                  <c:v>2.0912962342028711</c:v>
                </c:pt>
                <c:pt idx="27">
                  <c:v>30.473603329458832</c:v>
                </c:pt>
                <c:pt idx="28">
                  <c:v>12.31918515981679</c:v>
                </c:pt>
                <c:pt idx="29">
                  <c:v>1.5851704137453295</c:v>
                </c:pt>
                <c:pt idx="30">
                  <c:v>0.93222709051925046</c:v>
                </c:pt>
                <c:pt idx="33">
                  <c:v>9.056587369200237</c:v>
                </c:pt>
                <c:pt idx="34">
                  <c:v>0.3144385134353288</c:v>
                </c:pt>
              </c:numCache>
            </c:numRef>
          </c:val>
        </c:ser>
        <c:ser>
          <c:idx val="8"/>
          <c:order val="8"/>
          <c:tx>
            <c:strRef>
              <c:f>'C:\Users\Soham\Desktop\5th yr project\Abundance per million\[Segregation_flower.xlsx]Sheet3'!$K$8</c:f>
              <c:strCache>
                <c:ptCount val="1"/>
                <c:pt idx="0">
                  <c:v>UCGCUUGGUACAGGUCGGGAA</c:v>
                </c:pt>
              </c:strCache>
            </c:strRef>
          </c:tx>
          <c:invertIfNegative val="0"/>
          <c:cat>
            <c:strRef>
              <c:f>'C:\Users\Soham\Desktop\5th yr project\Abundance per million\[Segregation_flower.xlsx]Sheet3'!$B$9:$B$45</c:f>
              <c:strCache>
                <c:ptCount val="37"/>
                <c:pt idx="0">
                  <c:v>ppa</c:v>
                </c:pt>
                <c:pt idx="1">
                  <c:v>sma</c:v>
                </c:pt>
                <c:pt idx="2">
                  <c:v>mqu</c:v>
                </c:pt>
                <c:pt idx="3">
                  <c:v>cru</c:v>
                </c:pt>
                <c:pt idx="4">
                  <c:v>gbi (f)</c:v>
                </c:pt>
                <c:pt idx="5">
                  <c:v>gbi (m)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r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gma</c:v>
                </c:pt>
                <c:pt idx="28">
                  <c:v>pvu</c:v>
                </c:pt>
                <c:pt idx="29">
                  <c:v>sla</c:v>
                </c:pt>
                <c:pt idx="30">
                  <c:v>lsa</c:v>
                </c:pt>
                <c:pt idx="31">
                  <c:v>mgu</c:v>
                </c:pt>
                <c:pt idx="32">
                  <c:v>nta</c:v>
                </c:pt>
                <c:pt idx="33">
                  <c:v>phy</c:v>
                </c:pt>
                <c:pt idx="34">
                  <c:v>can</c:v>
                </c:pt>
                <c:pt idx="35">
                  <c:v>sly</c:v>
                </c:pt>
                <c:pt idx="36">
                  <c:v>stu</c:v>
                </c:pt>
              </c:strCache>
            </c:strRef>
          </c:cat>
          <c:val>
            <c:numRef>
              <c:f>'C:\Users\Soham\Desktop\5th yr project\Abundance per million\[Segregation_flower.xlsx]Sheet3'!$K$9:$K$45</c:f>
              <c:numCache>
                <c:formatCode>General</c:formatCode>
                <c:ptCount val="37"/>
                <c:pt idx="0">
                  <c:v>0</c:v>
                </c:pt>
                <c:pt idx="1">
                  <c:v>0</c:v>
                </c:pt>
                <c:pt idx="2">
                  <c:v>6.3421092269761621</c:v>
                </c:pt>
                <c:pt idx="11">
                  <c:v>0.71916007856104691</c:v>
                </c:pt>
                <c:pt idx="23">
                  <c:v>1.2482508884425698</c:v>
                </c:pt>
                <c:pt idx="25">
                  <c:v>2.1047432493868183</c:v>
                </c:pt>
                <c:pt idx="26">
                  <c:v>1.3941974894685807</c:v>
                </c:pt>
                <c:pt idx="27">
                  <c:v>3.2650289281563034</c:v>
                </c:pt>
                <c:pt idx="30">
                  <c:v>691.71250116528392</c:v>
                </c:pt>
                <c:pt idx="31">
                  <c:v>1.5217997818753646</c:v>
                </c:pt>
                <c:pt idx="33">
                  <c:v>0.30188624564000788</c:v>
                </c:pt>
              </c:numCache>
            </c:numRef>
          </c:val>
        </c:ser>
        <c:ser>
          <c:idx val="9"/>
          <c:order val="9"/>
          <c:tx>
            <c:strRef>
              <c:f>'C:\Users\Soham\Desktop\5th yr project\Abundance per million\[Segregation_flower.xlsx]Sheet3'!$L$8</c:f>
              <c:strCache>
                <c:ptCount val="1"/>
                <c:pt idx="0">
                  <c:v>Rest</c:v>
                </c:pt>
              </c:strCache>
            </c:strRef>
          </c:tx>
          <c:invertIfNegative val="0"/>
          <c:cat>
            <c:strRef>
              <c:f>'C:\Users\Soham\Desktop\5th yr project\Abundance per million\[Segregation_flower.xlsx]Sheet3'!$B$9:$B$45</c:f>
              <c:strCache>
                <c:ptCount val="37"/>
                <c:pt idx="0">
                  <c:v>ppa</c:v>
                </c:pt>
                <c:pt idx="1">
                  <c:v>sma</c:v>
                </c:pt>
                <c:pt idx="2">
                  <c:v>mqu</c:v>
                </c:pt>
                <c:pt idx="3">
                  <c:v>cru</c:v>
                </c:pt>
                <c:pt idx="4">
                  <c:v>gbi (f)</c:v>
                </c:pt>
                <c:pt idx="5">
                  <c:v>gbi (m)</c:v>
                </c:pt>
                <c:pt idx="6">
                  <c:v>pab</c:v>
                </c:pt>
                <c:pt idx="7">
                  <c:v>nad</c:v>
                </c:pt>
                <c:pt idx="8">
                  <c:v>afi</c:v>
                </c:pt>
                <c:pt idx="9">
                  <c:v>pam</c:v>
                </c:pt>
                <c:pt idx="10">
                  <c:v>zmr</c:v>
                </c:pt>
                <c:pt idx="11">
                  <c:v>mac</c:v>
                </c:pt>
                <c:pt idx="12">
                  <c:v>mgi</c:v>
                </c:pt>
                <c:pt idx="13">
                  <c:v>sbi</c:v>
                </c:pt>
                <c:pt idx="14">
                  <c:v>zma</c:v>
                </c:pt>
                <c:pt idx="15">
                  <c:v>pvi</c:v>
                </c:pt>
                <c:pt idx="16">
                  <c:v>sit</c:v>
                </c:pt>
                <c:pt idx="17">
                  <c:v>hvu</c:v>
                </c:pt>
                <c:pt idx="18">
                  <c:v>tae</c:v>
                </c:pt>
                <c:pt idx="19">
                  <c:v>osa</c:v>
                </c:pt>
                <c:pt idx="20">
                  <c:v>vvi</c:v>
                </c:pt>
                <c:pt idx="21">
                  <c:v>csi</c:v>
                </c:pt>
                <c:pt idx="22">
                  <c:v>cpa</c:v>
                </c:pt>
                <c:pt idx="23">
                  <c:v>gar</c:v>
                </c:pt>
                <c:pt idx="24">
                  <c:v>ath</c:v>
                </c:pt>
                <c:pt idx="25">
                  <c:v>cma</c:v>
                </c:pt>
                <c:pt idx="26">
                  <c:v>mtr</c:v>
                </c:pt>
                <c:pt idx="27">
                  <c:v>gma</c:v>
                </c:pt>
                <c:pt idx="28">
                  <c:v>pvu</c:v>
                </c:pt>
                <c:pt idx="29">
                  <c:v>sla</c:v>
                </c:pt>
                <c:pt idx="30">
                  <c:v>lsa</c:v>
                </c:pt>
                <c:pt idx="31">
                  <c:v>mgu</c:v>
                </c:pt>
                <c:pt idx="32">
                  <c:v>nta</c:v>
                </c:pt>
                <c:pt idx="33">
                  <c:v>phy</c:v>
                </c:pt>
                <c:pt idx="34">
                  <c:v>can</c:v>
                </c:pt>
                <c:pt idx="35">
                  <c:v>sly</c:v>
                </c:pt>
                <c:pt idx="36">
                  <c:v>stu</c:v>
                </c:pt>
              </c:strCache>
            </c:strRef>
          </c:cat>
          <c:val>
            <c:numRef>
              <c:f>'C:\Users\Soham\Desktop\5th yr project\Abundance per million\[Segregation_flower.xlsx]Sheet3'!$L$9:$L$45</c:f>
              <c:numCache>
                <c:formatCode>General</c:formatCode>
                <c:ptCount val="37"/>
                <c:pt idx="0">
                  <c:v>0</c:v>
                </c:pt>
                <c:pt idx="1">
                  <c:v>0</c:v>
                </c:pt>
                <c:pt idx="2">
                  <c:v>1861.4090581175035</c:v>
                </c:pt>
                <c:pt idx="3">
                  <c:v>395.74501314958763</c:v>
                </c:pt>
                <c:pt idx="4">
                  <c:v>814.447401912788</c:v>
                </c:pt>
                <c:pt idx="5">
                  <c:v>437.84338927102101</c:v>
                </c:pt>
                <c:pt idx="6">
                  <c:v>381.09398378379399</c:v>
                </c:pt>
                <c:pt idx="7">
                  <c:v>3129.0480539821565</c:v>
                </c:pt>
                <c:pt idx="8">
                  <c:v>546.46083810232062</c:v>
                </c:pt>
                <c:pt idx="9">
                  <c:v>129.0955190800276</c:v>
                </c:pt>
                <c:pt idx="10">
                  <c:v>531.10097603731822</c:v>
                </c:pt>
                <c:pt idx="11">
                  <c:v>589.71126442005846</c:v>
                </c:pt>
                <c:pt idx="12">
                  <c:v>617.53882272734904</c:v>
                </c:pt>
                <c:pt idx="13">
                  <c:v>4870.4720314641718</c:v>
                </c:pt>
                <c:pt idx="14">
                  <c:v>543.71073558135811</c:v>
                </c:pt>
                <c:pt idx="15">
                  <c:v>751.65120707488916</c:v>
                </c:pt>
                <c:pt idx="16">
                  <c:v>1115.7909150943187</c:v>
                </c:pt>
                <c:pt idx="17">
                  <c:v>782.03248989526207</c:v>
                </c:pt>
                <c:pt idx="18">
                  <c:v>465.10730404776427</c:v>
                </c:pt>
                <c:pt idx="19">
                  <c:v>3240.2909352656152</c:v>
                </c:pt>
                <c:pt idx="20">
                  <c:v>583.37068502430998</c:v>
                </c:pt>
                <c:pt idx="21">
                  <c:v>361.39278374284106</c:v>
                </c:pt>
                <c:pt idx="22">
                  <c:v>317.94832761588373</c:v>
                </c:pt>
                <c:pt idx="23">
                  <c:v>371.0425765895539</c:v>
                </c:pt>
                <c:pt idx="24">
                  <c:v>26.728391431946839</c:v>
                </c:pt>
                <c:pt idx="25">
                  <c:v>9154.2299726664005</c:v>
                </c:pt>
                <c:pt idx="26">
                  <c:v>472.63294892984885</c:v>
                </c:pt>
                <c:pt idx="27">
                  <c:v>629.06224015811449</c:v>
                </c:pt>
                <c:pt idx="28">
                  <c:v>389.28625105021058</c:v>
                </c:pt>
                <c:pt idx="29">
                  <c:v>389.1593365744784</c:v>
                </c:pt>
                <c:pt idx="30">
                  <c:v>474.50358907429853</c:v>
                </c:pt>
                <c:pt idx="31">
                  <c:v>1597.3825043751744</c:v>
                </c:pt>
                <c:pt idx="32">
                  <c:v>362.15174622922456</c:v>
                </c:pt>
                <c:pt idx="33">
                  <c:v>848.60223649406225</c:v>
                </c:pt>
                <c:pt idx="34">
                  <c:v>88.671660788762722</c:v>
                </c:pt>
                <c:pt idx="35">
                  <c:v>59.737272561262266</c:v>
                </c:pt>
                <c:pt idx="36">
                  <c:v>128.854509974268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2"/>
        <c:overlap val="100"/>
        <c:axId val="76788480"/>
        <c:axId val="76790016"/>
      </c:barChart>
      <c:catAx>
        <c:axId val="76788480"/>
        <c:scaling>
          <c:orientation val="minMax"/>
        </c:scaling>
        <c:delete val="0"/>
        <c:axPos val="b"/>
        <c:majorTickMark val="out"/>
        <c:minorTickMark val="none"/>
        <c:tickLblPos val="nextTo"/>
        <c:crossAx val="76790016"/>
        <c:crosses val="autoZero"/>
        <c:auto val="1"/>
        <c:lblAlgn val="ctr"/>
        <c:lblOffset val="100"/>
        <c:noMultiLvlLbl val="0"/>
      </c:catAx>
      <c:valAx>
        <c:axId val="76790016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extTo"/>
        <c:crossAx val="7678848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7647</cdr:x>
      <cdr:y>0.03155</cdr:y>
    </cdr:from>
    <cdr:to>
      <cdr:x>0.86828</cdr:x>
      <cdr:y>0.1001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143001" y="108936"/>
          <a:ext cx="4480850" cy="2367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1200" b="1" dirty="0">
              <a:latin typeface="Arial" pitchFamily="34" charset="0"/>
              <a:cs typeface="Arial" pitchFamily="34" charset="0"/>
            </a:rPr>
            <a:t>Abundance of different isoforms in reproductive tissues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19277</cdr:x>
      <cdr:y>0.08</cdr:y>
    </cdr:from>
    <cdr:to>
      <cdr:x>0.89157</cdr:x>
      <cdr:y>0.18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219193" y="304800"/>
          <a:ext cx="4419607" cy="3810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1200" b="1" dirty="0">
              <a:latin typeface="Arial" panose="020B0604020202020204" pitchFamily="34" charset="0"/>
              <a:cs typeface="Arial" panose="020B0604020202020204" pitchFamily="34" charset="0"/>
            </a:rPr>
            <a:t>% abundance of different isoforms in reproductive tissues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7965BD-FD03-4C8F-A197-EC50D7697508}" type="datetimeFigureOut">
              <a:rPr lang="en-US" smtClean="0"/>
              <a:t>8/25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ABED53-BBA4-43C4-9D66-9DCD963724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17183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1" y="561343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1" y="396731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31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6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61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1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25" y="2217387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25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94" y="2217387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94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25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312" y="394437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25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5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1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1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92142032"/>
              </p:ext>
            </p:extLst>
          </p:nvPr>
        </p:nvGraphicFramePr>
        <p:xfrm>
          <a:off x="228600" y="838231"/>
          <a:ext cx="6477000" cy="34528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57549810"/>
              </p:ext>
            </p:extLst>
          </p:nvPr>
        </p:nvGraphicFramePr>
        <p:xfrm>
          <a:off x="304800" y="4114800"/>
          <a:ext cx="6324600" cy="381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2770367" y="144429"/>
            <a:ext cx="22348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6</a:t>
            </a:r>
            <a:endParaRPr lang="en-US" dirty="0"/>
          </a:p>
        </p:txBody>
      </p:sp>
      <p:sp>
        <p:nvSpPr>
          <p:cNvPr id="5" name="TextBox 1"/>
          <p:cNvSpPr txBox="1"/>
          <p:nvPr/>
        </p:nvSpPr>
        <p:spPr>
          <a:xfrm rot="16200000">
            <a:off x="-430248" y="5970543"/>
            <a:ext cx="1292043" cy="178070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IN" sz="1050" b="0" dirty="0">
                <a:latin typeface="Arial" pitchFamily="34" charset="0"/>
                <a:cs typeface="Arial" pitchFamily="34" charset="0"/>
              </a:rPr>
              <a:t>Reads per million</a:t>
            </a:r>
          </a:p>
        </p:txBody>
      </p:sp>
      <p:sp>
        <p:nvSpPr>
          <p:cNvPr id="6" name="TextBox 1"/>
          <p:cNvSpPr txBox="1"/>
          <p:nvPr/>
        </p:nvSpPr>
        <p:spPr>
          <a:xfrm rot="16200000">
            <a:off x="-480782" y="2309587"/>
            <a:ext cx="1292043" cy="178070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IN" sz="1050" b="0" dirty="0">
                <a:latin typeface="Arial" pitchFamily="34" charset="0"/>
                <a:cs typeface="Arial" pitchFamily="34" charset="0"/>
              </a:rPr>
              <a:t>Reads per million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83230" y="389413"/>
            <a:ext cx="7381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(A)</a:t>
            </a:r>
            <a:endParaRPr lang="en-US" sz="1600" dirty="0"/>
          </a:p>
        </p:txBody>
      </p:sp>
      <p:sp>
        <p:nvSpPr>
          <p:cNvPr id="8" name="TextBox 7"/>
          <p:cNvSpPr txBox="1"/>
          <p:nvPr/>
        </p:nvSpPr>
        <p:spPr>
          <a:xfrm>
            <a:off x="483230" y="4343400"/>
            <a:ext cx="7381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(B)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304809" y="8001000"/>
            <a:ext cx="632459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Figure S6.</a:t>
            </a:r>
            <a:r>
              <a:rPr lang="en-US" sz="1200" dirty="0" smtClean="0"/>
              <a:t>  </a:t>
            </a:r>
            <a:r>
              <a:rPr lang="en-US" sz="1200" dirty="0"/>
              <a:t>Abundance and sequence diversity of miR168 members across plant families in reproductive tissues.  </a:t>
            </a:r>
            <a:r>
              <a:rPr lang="en-US" sz="1200" b="1" dirty="0"/>
              <a:t>a</a:t>
            </a:r>
            <a:r>
              <a:rPr lang="en-US" sz="1200" dirty="0"/>
              <a:t>  abundance of miR168.  Color bars represent most abundant forms of miR168 in reproductive tissues. Blue, red and green bars represent monocot, dicot and </a:t>
            </a:r>
            <a:r>
              <a:rPr lang="en-US" sz="1200" i="1" dirty="0" err="1"/>
              <a:t>Solanaceae</a:t>
            </a:r>
            <a:r>
              <a:rPr lang="en-US" sz="1200" dirty="0"/>
              <a:t>-specific forms as shown in Fig. 1.  </a:t>
            </a:r>
            <a:r>
              <a:rPr lang="en-US" sz="1200" b="1" dirty="0"/>
              <a:t>b</a:t>
            </a:r>
            <a:r>
              <a:rPr lang="en-US" sz="1200" dirty="0"/>
              <a:t> Percentage abundance of miR168 across plant families.  </a:t>
            </a:r>
          </a:p>
        </p:txBody>
      </p:sp>
    </p:spTree>
    <p:extLst>
      <p:ext uri="{BB962C8B-B14F-4D97-AF65-F5344CB8AC3E}">
        <p14:creationId xmlns:p14="http://schemas.microsoft.com/office/powerpoint/2010/main" val="36976830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19</TotalTime>
  <Words>92</Words>
  <Application>Microsoft Office PowerPoint</Application>
  <PresentationFormat>A4 Paper (210x297 mm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vaprasad</dc:creator>
  <cp:lastModifiedBy>Shivaprasad</cp:lastModifiedBy>
  <cp:revision>128</cp:revision>
  <dcterms:created xsi:type="dcterms:W3CDTF">2006-08-16T00:00:00Z</dcterms:created>
  <dcterms:modified xsi:type="dcterms:W3CDTF">2014-08-25T07:05:48Z</dcterms:modified>
</cp:coreProperties>
</file>